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86" r:id="rId2"/>
    <p:sldId id="259" r:id="rId3"/>
    <p:sldId id="294" r:id="rId4"/>
    <p:sldId id="273" r:id="rId5"/>
    <p:sldId id="289" r:id="rId6"/>
    <p:sldId id="292" r:id="rId7"/>
    <p:sldId id="293" r:id="rId8"/>
    <p:sldId id="296" r:id="rId9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柳沼 秀幸" initials="柳沼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893" autoAdjust="0"/>
    <p:restoredTop sz="96327"/>
  </p:normalViewPr>
  <p:slideViewPr>
    <p:cSldViewPr snapToGrid="0">
      <p:cViewPr>
        <p:scale>
          <a:sx n="236" d="100"/>
          <a:sy n="236" d="100"/>
        </p:scale>
        <p:origin x="928" y="144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9A6C74-7CAD-40BC-935A-4A0629BEC808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71D138-E3A9-4AB3-9086-2551D83DB2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1639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182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4500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8158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8317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7879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8141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122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916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4190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6379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276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ADF2C-8F67-4997-850E-BB01A394EA2D}" type="datetimeFigureOut">
              <a:rPr kumimoji="1" lang="ja-JP" altLang="en-US" smtClean="0"/>
              <a:t>2021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385D7-5EDB-4528-BFA5-9CC06C7DF0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8246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10" y="642953"/>
            <a:ext cx="4751842" cy="871425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612F9DE-73F2-A14E-B0B4-E9D2E7286B84}"/>
              </a:ext>
            </a:extLst>
          </p:cNvPr>
          <p:cNvSpPr txBox="1"/>
          <p:nvPr/>
        </p:nvSpPr>
        <p:spPr>
          <a:xfrm>
            <a:off x="38910" y="273621"/>
            <a:ext cx="2269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43985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38910" y="257292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2</a:t>
            </a:r>
            <a:endParaRPr kumimoji="1" lang="ja-JP" altLang="en-US" dirty="0"/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1257" y="800801"/>
            <a:ext cx="6306863" cy="79839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52170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C9CCAE9-F66B-C54B-B2D8-C51F88B0FF0D}"/>
              </a:ext>
            </a:extLst>
          </p:cNvPr>
          <p:cNvSpPr txBox="1"/>
          <p:nvPr/>
        </p:nvSpPr>
        <p:spPr>
          <a:xfrm>
            <a:off x="38910" y="273621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3</a:t>
            </a:r>
            <a:endParaRPr kumimoji="1" lang="ja-JP" altLang="en-US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416E51D9-CBBF-004C-9067-49C95F4B51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360" y="1097920"/>
            <a:ext cx="6407279" cy="72949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80101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38910" y="273621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. S4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0" y="2786667"/>
            <a:ext cx="6858000" cy="1979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22687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38910" y="273621"/>
            <a:ext cx="141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+mj-lt"/>
              </a:rPr>
              <a:t>Sup. Table S1</a:t>
            </a:r>
            <a:endParaRPr kumimoji="1" lang="ja-JP" altLang="en-US" dirty="0">
              <a:latin typeface="+mj-lt"/>
            </a:endParaRPr>
          </a:p>
        </p:txBody>
      </p:sp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E95B203C-0EDF-0240-8152-80F1E58344A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6448548"/>
              </p:ext>
            </p:extLst>
          </p:nvPr>
        </p:nvGraphicFramePr>
        <p:xfrm>
          <a:off x="361951" y="7669371"/>
          <a:ext cx="2705100" cy="1473200"/>
        </p:xfrm>
        <a:graphic>
          <a:graphicData uri="http://schemas.openxmlformats.org/drawingml/2006/table">
            <a:tbl>
              <a:tblPr/>
              <a:tblGrid>
                <a:gridCol w="1534898">
                  <a:extLst>
                    <a:ext uri="{9D8B030D-6E8A-4147-A177-3AD203B41FA5}">
                      <a16:colId xmlns:a16="http://schemas.microsoft.com/office/drawing/2014/main" val="3825771606"/>
                    </a:ext>
                  </a:extLst>
                </a:gridCol>
                <a:gridCol w="1170202">
                  <a:extLst>
                    <a:ext uri="{9D8B030D-6E8A-4147-A177-3AD203B41FA5}">
                      <a16:colId xmlns:a16="http://schemas.microsoft.com/office/drawing/2014/main" val="3350677807"/>
                    </a:ext>
                  </a:extLst>
                </a:gridCol>
              </a:tblGrid>
              <a:tr h="660400"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Estimated </a:t>
                      </a:r>
                      <a:r>
                        <a:rPr lang="en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</a:t>
                      </a:r>
                      <a:r>
                        <a:rPr lang="en" sz="11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d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Meiryo UI" panose="020B0604030504040204" pitchFamily="34" charset="-128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Affinity to AT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21509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ca. 0.01 m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1983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ca. 0.1 m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86608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ca. 1 m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451007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ca. 10 mM or m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4282666"/>
                  </a:ext>
                </a:extLst>
              </a:tr>
            </a:tbl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8783E7C-B2B6-E547-A1C9-389439C98465}"/>
              </a:ext>
            </a:extLst>
          </p:cNvPr>
          <p:cNvSpPr txBox="1"/>
          <p:nvPr/>
        </p:nvSpPr>
        <p:spPr>
          <a:xfrm>
            <a:off x="5314949" y="7604186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+mj-lt"/>
              </a:rPr>
              <a:t>ND = No Data</a:t>
            </a:r>
            <a:endParaRPr kumimoji="1" lang="ja-JP" altLang="en-US" sz="1000">
              <a:latin typeface="+mj-lt"/>
            </a:endParaRPr>
          </a:p>
        </p:txBody>
      </p:sp>
      <p:graphicFrame>
        <p:nvGraphicFramePr>
          <p:cNvPr id="15" name="表 14">
            <a:extLst>
              <a:ext uri="{FF2B5EF4-FFF2-40B4-BE49-F238E27FC236}">
                <a16:creationId xmlns:a16="http://schemas.microsoft.com/office/drawing/2014/main" id="{453AA185-55B6-3945-9AE4-EE510D3A5A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6491472"/>
              </p:ext>
            </p:extLst>
          </p:nvPr>
        </p:nvGraphicFramePr>
        <p:xfrm>
          <a:off x="361951" y="763429"/>
          <a:ext cx="5844589" cy="6840757"/>
        </p:xfrm>
        <a:graphic>
          <a:graphicData uri="http://schemas.openxmlformats.org/drawingml/2006/table">
            <a:tbl>
              <a:tblPr/>
              <a:tblGrid>
                <a:gridCol w="309116">
                  <a:extLst>
                    <a:ext uri="{9D8B030D-6E8A-4147-A177-3AD203B41FA5}">
                      <a16:colId xmlns:a16="http://schemas.microsoft.com/office/drawing/2014/main" val="2986226246"/>
                    </a:ext>
                  </a:extLst>
                </a:gridCol>
                <a:gridCol w="1021801">
                  <a:extLst>
                    <a:ext uri="{9D8B030D-6E8A-4147-A177-3AD203B41FA5}">
                      <a16:colId xmlns:a16="http://schemas.microsoft.com/office/drawing/2014/main" val="1718979457"/>
                    </a:ext>
                  </a:extLst>
                </a:gridCol>
                <a:gridCol w="1831801">
                  <a:extLst>
                    <a:ext uri="{9D8B030D-6E8A-4147-A177-3AD203B41FA5}">
                      <a16:colId xmlns:a16="http://schemas.microsoft.com/office/drawing/2014/main" val="1478181991"/>
                    </a:ext>
                  </a:extLst>
                </a:gridCol>
                <a:gridCol w="609647">
                  <a:extLst>
                    <a:ext uri="{9D8B030D-6E8A-4147-A177-3AD203B41FA5}">
                      <a16:colId xmlns:a16="http://schemas.microsoft.com/office/drawing/2014/main" val="53632098"/>
                    </a:ext>
                  </a:extLst>
                </a:gridCol>
                <a:gridCol w="824310">
                  <a:extLst>
                    <a:ext uri="{9D8B030D-6E8A-4147-A177-3AD203B41FA5}">
                      <a16:colId xmlns:a16="http://schemas.microsoft.com/office/drawing/2014/main" val="271312030"/>
                    </a:ext>
                  </a:extLst>
                </a:gridCol>
                <a:gridCol w="698374">
                  <a:extLst>
                    <a:ext uri="{9D8B030D-6E8A-4147-A177-3AD203B41FA5}">
                      <a16:colId xmlns:a16="http://schemas.microsoft.com/office/drawing/2014/main" val="3238058676"/>
                    </a:ext>
                  </a:extLst>
                </a:gridCol>
                <a:gridCol w="549540">
                  <a:extLst>
                    <a:ext uri="{9D8B030D-6E8A-4147-A177-3AD203B41FA5}">
                      <a16:colId xmlns:a16="http://schemas.microsoft.com/office/drawing/2014/main" val="1411488226"/>
                    </a:ext>
                  </a:extLst>
                </a:gridCol>
              </a:tblGrid>
              <a:tr h="472277"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34" charset="-128"/>
                        </a:rPr>
                        <a:t>No.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34" charset="-128"/>
                        </a:rPr>
                        <a:t>base QUEEN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34" charset="-128"/>
                        </a:rPr>
                        <a:t>mutation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34" charset="-128"/>
                        </a:rPr>
                        <a:t>Affinity to ATP (crude)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34" charset="-128"/>
                        </a:rPr>
                        <a:t>Kd (mM)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34" charset="-128"/>
                        </a:rPr>
                        <a:t>Hill Coeff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Meiryo UI" panose="020B0604030504040204" pitchFamily="34" charset="-128"/>
                        </a:rPr>
                        <a:t>Temp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8179017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/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6.39E-0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14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324367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Meiryo UI" panose="020B0604030504040204" pitchFamily="34" charset="-128"/>
                      </a:endParaRP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/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67E-0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2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4695440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A81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7.02E-0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1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814892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A81I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23E-0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49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4312654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4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E83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731863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D89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03E-0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2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5535171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6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V90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17E-0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3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2616865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A81E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6.90E-0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1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7054606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8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I88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-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355777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9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26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7471996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28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5179497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1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51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9145177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53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37E-0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1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771981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54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5739614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4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57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2675266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71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6442204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6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74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2567830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84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7706460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8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92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46E-01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6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291771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9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94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3580210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97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8846011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1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99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390609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102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237653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103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-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1110498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4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114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0461107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115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-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3774601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6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K121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+++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6.49E-0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11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260145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122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23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5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663298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　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122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.33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3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6344320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8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126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-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7184512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9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7µ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R126I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-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4927453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84BP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/A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9.12E-01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24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2417677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1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84BP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M60E M132K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48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1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7654951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2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84BP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M60E M132E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29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8709954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84BP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M60D M132D (QUEEN-37C)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99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1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4847450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Meiryo UI" panose="020B0604030504040204" pitchFamily="34" charset="-128"/>
                      </a:endParaRP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84BP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M60D M132D (QUEEN-37C)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6.01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355822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4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84BP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M60K M132K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31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2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4465117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5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 84BP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M60R M132R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29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.39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5753509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6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-2m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M60E M132K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26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93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1611196"/>
                  </a:ext>
                </a:extLst>
              </a:tr>
              <a:tr h="14531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7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QUEEN-2m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M60D M132D (QUEEN-20C)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ND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3.50E+0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1.84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Meiryo UI" panose="020B0604030504040204" pitchFamily="34" charset="-128"/>
                        </a:rPr>
                        <a:t>20</a:t>
                      </a:r>
                    </a:p>
                  </a:txBody>
                  <a:tcPr marL="6812" marR="6812" marT="68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28378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080898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B8135EB-1C79-8141-B1B0-9F94F6A758CA}"/>
              </a:ext>
            </a:extLst>
          </p:cNvPr>
          <p:cNvSpPr txBox="1"/>
          <p:nvPr/>
        </p:nvSpPr>
        <p:spPr>
          <a:xfrm>
            <a:off x="151860" y="1132895"/>
            <a:ext cx="141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 Table S2</a:t>
            </a:r>
            <a:endParaRPr kumimoji="1" lang="ja-JP" altLang="en-US" dirty="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57B8DBDF-AB00-C947-B6B9-9C0EC8C5C5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3318635"/>
              </p:ext>
            </p:extLst>
          </p:nvPr>
        </p:nvGraphicFramePr>
        <p:xfrm>
          <a:off x="185057" y="1586001"/>
          <a:ext cx="6487886" cy="7053989"/>
        </p:xfrm>
        <a:graphic>
          <a:graphicData uri="http://schemas.openxmlformats.org/drawingml/2006/table">
            <a:tbl>
              <a:tblPr/>
              <a:tblGrid>
                <a:gridCol w="1100779">
                  <a:extLst>
                    <a:ext uri="{9D8B030D-6E8A-4147-A177-3AD203B41FA5}">
                      <a16:colId xmlns:a16="http://schemas.microsoft.com/office/drawing/2014/main" val="990416381"/>
                    </a:ext>
                  </a:extLst>
                </a:gridCol>
                <a:gridCol w="988016">
                  <a:extLst>
                    <a:ext uri="{9D8B030D-6E8A-4147-A177-3AD203B41FA5}">
                      <a16:colId xmlns:a16="http://schemas.microsoft.com/office/drawing/2014/main" val="2927598558"/>
                    </a:ext>
                  </a:extLst>
                </a:gridCol>
                <a:gridCol w="596032">
                  <a:extLst>
                    <a:ext uri="{9D8B030D-6E8A-4147-A177-3AD203B41FA5}">
                      <a16:colId xmlns:a16="http://schemas.microsoft.com/office/drawing/2014/main" val="1400746343"/>
                    </a:ext>
                  </a:extLst>
                </a:gridCol>
                <a:gridCol w="1922337">
                  <a:extLst>
                    <a:ext uri="{9D8B030D-6E8A-4147-A177-3AD203B41FA5}">
                      <a16:colId xmlns:a16="http://schemas.microsoft.com/office/drawing/2014/main" val="1685414306"/>
                    </a:ext>
                  </a:extLst>
                </a:gridCol>
                <a:gridCol w="1880722">
                  <a:extLst>
                    <a:ext uri="{9D8B030D-6E8A-4147-A177-3AD203B41FA5}">
                      <a16:colId xmlns:a16="http://schemas.microsoft.com/office/drawing/2014/main" val="4120155126"/>
                    </a:ext>
                  </a:extLst>
                </a:gridCol>
              </a:tblGrid>
              <a:tr h="364579">
                <a:tc>
                  <a:txBody>
                    <a:bodyPr/>
                    <a:lstStyle/>
                    <a:p>
                      <a:pPr algn="l" fontAlgn="b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lasmid Name</a:t>
                      </a:r>
                    </a:p>
                  </a:txBody>
                  <a:tcPr marL="3672" marR="3672" marT="36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Gene or insert Name</a:t>
                      </a:r>
                    </a:p>
                  </a:txBody>
                  <a:tcPr marL="3672" marR="3672" marT="36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Addgene Deposit Number</a:t>
                      </a:r>
                    </a:p>
                  </a:txBody>
                  <a:tcPr marL="3672" marR="3672" marT="36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8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urpose of backbone plasmid</a:t>
                      </a:r>
                    </a:p>
                  </a:txBody>
                  <a:tcPr marL="3672" marR="3672" marT="36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urpose of expressed protein</a:t>
                      </a:r>
                    </a:p>
                  </a:txBody>
                  <a:tcPr marL="3672" marR="3672" marT="36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194347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-QUE7µ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-7µ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11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igh ATP affinity QUEEN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6673132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2m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-2m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0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ysiological ATP measurement at 25º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2393656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AN-QUEEN 84BP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84BP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8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5920276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AN-QUEEN BPEK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BPEK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9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0632142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AN-QUEEN BPE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BPE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80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6607504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AN-QUEEN BPKK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BPKK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81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7184165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AN-QUEEN BPRR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BPRR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82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4113850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AN-QUE37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-37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12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ysiological ATP measurement at 37º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8504562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A81D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A81D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1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305799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A81I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A81I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2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8715271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E83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E83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3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1016968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D89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D89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4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8104353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V90D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V90D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5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0927754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A81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A81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6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1567896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I88D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I88D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7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286913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7µ R122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-7µ R122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17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4482933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26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26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8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214225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28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28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59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6091366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R51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R51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0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0988019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53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53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1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2379610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5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5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2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2565806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57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57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3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737237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71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71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4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4049851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7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7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5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4870037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R8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R8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6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8364122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R92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R92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7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1556348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9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9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8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2550269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97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97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69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4966525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R99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R99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0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8316800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R102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R102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1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3385715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R103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R103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2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7213910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11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114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3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1707160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R115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R115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4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4142608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 QUEEN7µ K121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 QUEEN7µ K121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5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0906717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R126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R126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6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5763378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ET-QUEEN 7µ R126I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 7µ R126I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77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w ATP indicator candidate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3829015"/>
                  </a:ext>
                </a:extLst>
              </a:tr>
              <a:tr h="108902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RSAN-QUE20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-20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16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xpression in </a:t>
                      </a:r>
                      <a:r>
                        <a:rPr lang="en" sz="700" b="0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. coli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ysiological ATP measurement at 20º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3535279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T2MP.EF-QUE37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-37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32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Tol2 transposon system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ysiological ATP measurement at 37º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995168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LBS.CAG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49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/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6234449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LBS.EF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35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/A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5756008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37C/pLBS.CAG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-37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40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ysiological ATP measurement at 37º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1952743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LBS-EF-QUE37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QUEEN-37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38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ysiological ATP measurement at 37ºC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839372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T2MP.EF-pHlu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luorin (from H. Imamura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04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Tol2 transposon system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 indicator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2244122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LBS.EF NLS-pHlu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luorin (from H. Imamura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24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H indicator, nucleus localization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1830904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LBS.EF/miRFP670-hGem110Nt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miRFP670  (Addgene 80006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33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cell cycle marker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7729308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LBS.EF/mScarlet(i)-hCdt100Nt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mScarlet(i) (Addgene 85044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34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cell cycle marker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2289490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LBS-mScarlet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mScarlet (Addgene 85042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37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fluorescent protein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474473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LBS.EF-iRFP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iRFP (from Dr. M. Matsuda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29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able expression in mammalian cells (lentivirus production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fluorescent protein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4648128"/>
                  </a:ext>
                </a:extLst>
              </a:tr>
              <a:tr h="214181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pN1/G3BP1-iRFP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iRFP (from Dr. M. Matsuda)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129339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Transient expression in mammalian cells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stress granule formation indicator</a:t>
                      </a:r>
                    </a:p>
                  </a:txBody>
                  <a:tcPr marL="3672" marR="3672" marT="367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50474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212214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506AA22-30C9-E843-87CD-A181A71EFB1B}"/>
              </a:ext>
            </a:extLst>
          </p:cNvPr>
          <p:cNvSpPr txBox="1"/>
          <p:nvPr/>
        </p:nvSpPr>
        <p:spPr>
          <a:xfrm>
            <a:off x="151860" y="1132895"/>
            <a:ext cx="141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 Table S3</a:t>
            </a:r>
            <a:endParaRPr kumimoji="1" lang="ja-JP" altLang="en-US" dirty="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C2A6E65D-15C1-5148-8C08-63888DA2B0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8828560"/>
              </p:ext>
            </p:extLst>
          </p:nvPr>
        </p:nvGraphicFramePr>
        <p:xfrm>
          <a:off x="275545" y="1672721"/>
          <a:ext cx="5915024" cy="5222472"/>
        </p:xfrm>
        <a:graphic>
          <a:graphicData uri="http://schemas.openxmlformats.org/drawingml/2006/table">
            <a:tbl>
              <a:tblPr/>
              <a:tblGrid>
                <a:gridCol w="965023">
                  <a:extLst>
                    <a:ext uri="{9D8B030D-6E8A-4147-A177-3AD203B41FA5}">
                      <a16:colId xmlns:a16="http://schemas.microsoft.com/office/drawing/2014/main" val="3483514182"/>
                    </a:ext>
                  </a:extLst>
                </a:gridCol>
                <a:gridCol w="1294266">
                  <a:extLst>
                    <a:ext uri="{9D8B030D-6E8A-4147-A177-3AD203B41FA5}">
                      <a16:colId xmlns:a16="http://schemas.microsoft.com/office/drawing/2014/main" val="1581511079"/>
                    </a:ext>
                  </a:extLst>
                </a:gridCol>
                <a:gridCol w="3655735">
                  <a:extLst>
                    <a:ext uri="{9D8B030D-6E8A-4147-A177-3AD203B41FA5}">
                      <a16:colId xmlns:a16="http://schemas.microsoft.com/office/drawing/2014/main" val="2660294798"/>
                    </a:ext>
                  </a:extLst>
                </a:gridCol>
              </a:tblGrid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Cell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Cell Catalog No.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1" i="0" u="none" strike="noStrike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34" charset="-128"/>
                          <a:ea typeface="游ゴシック" panose="020B0400000000000000" pitchFamily="34" charset="-128"/>
                        </a:rPr>
                        <a:t>Medium*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6819607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A549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3677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10%FBS+0.1mM NEA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9582226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astrocyte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/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b4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2274884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C2C12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0987  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DMEM(LG)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2230477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CaCo2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0988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20%FBS+0.1mM NEA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6091153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CHO-K1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2869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amF12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9868534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CT116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2979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DMEM(LG)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3459268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EK293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1637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10%FBS+0.1mM NEA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7332617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eL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0007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3036544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ep-G2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1886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DMEM(LG)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0512443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T1080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JCRB9113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6515065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uh-7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1942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PMI1640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7797241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UVEC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C-12200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ndothelial Cell Growth Medium 2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4386603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L929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2619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PMI1640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2604408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MCF7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1904 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10%FBS+0.1mM NEAA+1mM Pyruvate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5509482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MEF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/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DMEM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1284769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uro2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IFO50081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5684482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euron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/A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b4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0056242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NIH3T3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2767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DMEM(LG)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2470913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TERT-RPE1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CRL-4000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DMEM/Ham's F-12 + 10%FBS + 0.01mg/mL </a:t>
                      </a:r>
                      <a:r>
                        <a:rPr lang="en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HygB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游ゴシック" panose="020B0400000000000000" pitchFamily="34" charset="-128"/>
                      </a:endParaRP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5930227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U-2 O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C92022711-F0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McCoy's 5a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5537059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U-251MG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 IFO50288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635861"/>
                  </a:ext>
                </a:extLst>
              </a:tr>
              <a:tr h="227064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WI-38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RCB0702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游ゴシック" panose="020B0400000000000000" pitchFamily="34" charset="-128"/>
                        </a:rPr>
                        <a:t>EMEM+10%FBS</a:t>
                      </a:r>
                    </a:p>
                  </a:txBody>
                  <a:tcPr marL="8515" marR="8515" marT="8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7193702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9794A32-64A4-0149-BAB6-C4D5D65907EC}"/>
              </a:ext>
            </a:extLst>
          </p:cNvPr>
          <p:cNvSpPr txBox="1"/>
          <p:nvPr/>
        </p:nvSpPr>
        <p:spPr>
          <a:xfrm>
            <a:off x="151860" y="6895193"/>
            <a:ext cx="603870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050" dirty="0"/>
              <a:t>*All culture media except those for neuron, astrocyte and hTERT-RPE1 contains final 10 U/mL Penicillin-Streptomycin.</a:t>
            </a:r>
            <a:endParaRPr kumimoji="1" lang="ja-JP" altLang="en-US" sz="1050"/>
          </a:p>
        </p:txBody>
      </p:sp>
    </p:spTree>
    <p:extLst>
      <p:ext uri="{BB962C8B-B14F-4D97-AF65-F5344CB8AC3E}">
        <p14:creationId xmlns:p14="http://schemas.microsoft.com/office/powerpoint/2010/main" val="26669863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4FE9F6-FB4F-4E42-8F4A-17AFBA51E4FF}"/>
              </a:ext>
            </a:extLst>
          </p:cNvPr>
          <p:cNvSpPr txBox="1"/>
          <p:nvPr/>
        </p:nvSpPr>
        <p:spPr>
          <a:xfrm>
            <a:off x="112186" y="2869167"/>
            <a:ext cx="141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 Table S4</a:t>
            </a:r>
            <a:endParaRPr kumimoji="1" lang="ja-JP" altLang="en-US" dirty="0"/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E33C957C-9B02-8E4F-A818-3687E4472C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7923140"/>
              </p:ext>
            </p:extLst>
          </p:nvPr>
        </p:nvGraphicFramePr>
        <p:xfrm>
          <a:off x="112186" y="3390899"/>
          <a:ext cx="6514917" cy="2737758"/>
        </p:xfrm>
        <a:graphic>
          <a:graphicData uri="http://schemas.openxmlformats.org/drawingml/2006/table">
            <a:tbl>
              <a:tblPr/>
              <a:tblGrid>
                <a:gridCol w="509243">
                  <a:extLst>
                    <a:ext uri="{9D8B030D-6E8A-4147-A177-3AD203B41FA5}">
                      <a16:colId xmlns:a16="http://schemas.microsoft.com/office/drawing/2014/main" val="2429854342"/>
                    </a:ext>
                  </a:extLst>
                </a:gridCol>
                <a:gridCol w="1033764">
                  <a:extLst>
                    <a:ext uri="{9D8B030D-6E8A-4147-A177-3AD203B41FA5}">
                      <a16:colId xmlns:a16="http://schemas.microsoft.com/office/drawing/2014/main" val="612212170"/>
                    </a:ext>
                  </a:extLst>
                </a:gridCol>
                <a:gridCol w="1004907">
                  <a:extLst>
                    <a:ext uri="{9D8B030D-6E8A-4147-A177-3AD203B41FA5}">
                      <a16:colId xmlns:a16="http://schemas.microsoft.com/office/drawing/2014/main" val="2438971545"/>
                    </a:ext>
                  </a:extLst>
                </a:gridCol>
                <a:gridCol w="626369">
                  <a:extLst>
                    <a:ext uri="{9D8B030D-6E8A-4147-A177-3AD203B41FA5}">
                      <a16:colId xmlns:a16="http://schemas.microsoft.com/office/drawing/2014/main" val="459207602"/>
                    </a:ext>
                  </a:extLst>
                </a:gridCol>
                <a:gridCol w="1018486">
                  <a:extLst>
                    <a:ext uri="{9D8B030D-6E8A-4147-A177-3AD203B41FA5}">
                      <a16:colId xmlns:a16="http://schemas.microsoft.com/office/drawing/2014/main" val="3541697259"/>
                    </a:ext>
                  </a:extLst>
                </a:gridCol>
                <a:gridCol w="509243">
                  <a:extLst>
                    <a:ext uri="{9D8B030D-6E8A-4147-A177-3AD203B41FA5}">
                      <a16:colId xmlns:a16="http://schemas.microsoft.com/office/drawing/2014/main" val="3499930504"/>
                    </a:ext>
                  </a:extLst>
                </a:gridCol>
                <a:gridCol w="509243">
                  <a:extLst>
                    <a:ext uri="{9D8B030D-6E8A-4147-A177-3AD203B41FA5}">
                      <a16:colId xmlns:a16="http://schemas.microsoft.com/office/drawing/2014/main" val="1186016452"/>
                    </a:ext>
                  </a:extLst>
                </a:gridCol>
                <a:gridCol w="1303662">
                  <a:extLst>
                    <a:ext uri="{9D8B030D-6E8A-4147-A177-3AD203B41FA5}">
                      <a16:colId xmlns:a16="http://schemas.microsoft.com/office/drawing/2014/main" val="1377886307"/>
                    </a:ext>
                  </a:extLst>
                </a:gridCol>
              </a:tblGrid>
              <a:tr h="305705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Short ID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another name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Stable Cell Line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Method of transformation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Plasmid for transformation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Plasmid number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Original cell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Selection after transformation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865210"/>
                  </a:ext>
                </a:extLst>
              </a:tr>
              <a:tr h="135869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92A1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-Q37C-192A1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Tol2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T2MP-EF-QUEEN37C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32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CK I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ropagated from single colony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536999"/>
                  </a:ext>
                </a:extLst>
              </a:tr>
              <a:tr h="135869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209A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-pHlu-209A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Hluorin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Tol2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T2MPEF-pHlu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04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CK I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ropagated from single colony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144642"/>
                  </a:ext>
                </a:extLst>
              </a:tr>
              <a:tr h="135869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691D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-Q37C-691D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 (Q37Low)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Tol2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T2MP-EF-QUEEN37C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32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CK I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ropagated from single colony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1042860"/>
                  </a:ext>
                </a:extLst>
              </a:tr>
              <a:tr h="135869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723A9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-NucpHlu-723A9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NLS-pHluorin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lent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LBS.EF NLS-pHlu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24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CK I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ropagated from single colony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5480512"/>
                  </a:ext>
                </a:extLst>
              </a:tr>
              <a:tr h="230977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722H7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-Q37C/NucpHlu-722H7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 (Q37Low), NLS-pHluorin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Tol2, lent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T2MP-EF-QUEEN37C, pLBS.EF NLS-pHlu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32, 129324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CK I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ropagated from single colony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7531970"/>
                  </a:ext>
                </a:extLst>
              </a:tr>
              <a:tr h="346465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795G1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-Q37C/GemRFP-795G1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, FUCCI(Gem)-miRFP670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Tol2, lent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T2MP-EF-QUEEN37C, pLBS.EF/miRFP670-hGem110Nt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32, 129333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CK I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ropagated from single colony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6152685"/>
                  </a:ext>
                </a:extLst>
              </a:tr>
              <a:tr h="13586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798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HEK-Q37C-798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lent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37C/pLBS.CAG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40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HEK293T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No selection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5158041"/>
                  </a:ext>
                </a:extLst>
              </a:tr>
              <a:tr h="577443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811E4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-Q37C/GemRFP/CdtSca-811E4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, FUCCI(Gem)-miRFP670, FUCCI(Cdt)-mScarlet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Tol2, lent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T2MP-EF-QUEEN37C, pLBS.EF/miRFP670-hGem110Nt, pLBS.EF/mScarlet(i)-hCdt100Nt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32, 129333, 129334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DCK I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ropagated from single colony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0065240"/>
                  </a:ext>
                </a:extLst>
              </a:tr>
              <a:tr h="135869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810C5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EB-Q37C-810C5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lent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LBS-EF-QUEEN37C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38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ES EB5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ropagated from single colony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3705400"/>
                  </a:ext>
                </a:extLst>
              </a:tr>
              <a:tr h="230977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842S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EB-Q37C/iRFP-842S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, iRFP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lent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LBS-EF-QUEEN37C, pLBS.EF-iRFP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38, 129329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ES EB5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Selected by FACS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9744007"/>
                  </a:ext>
                </a:extLst>
              </a:tr>
              <a:tr h="230977"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843S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EB-Q37C/Sca-843S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QUEEN-37C, mScarlet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lenti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pLBS-EF-QUEEN37C, pLBS-mScarlet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129338, 129337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mES EB5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游ゴシック" panose="020B0400000000000000" pitchFamily="34" charset="-128"/>
                        </a:rPr>
                        <a:t>Selected by FACS</a:t>
                      </a:r>
                    </a:p>
                  </a:txBody>
                  <a:tcPr marL="5095" marR="5095" marT="50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041534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73157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358</TotalTime>
  <Words>1735</Words>
  <Application>Microsoft Macintosh PowerPoint</Application>
  <PresentationFormat>A4 210 x 297 mm</PresentationFormat>
  <Paragraphs>720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柳沼 秀幸</dc:creator>
  <cp:lastModifiedBy>柳沼　秀幸</cp:lastModifiedBy>
  <cp:revision>117</cp:revision>
  <cp:lastPrinted>2018-09-10T01:02:58Z</cp:lastPrinted>
  <dcterms:created xsi:type="dcterms:W3CDTF">2018-06-30T07:33:30Z</dcterms:created>
  <dcterms:modified xsi:type="dcterms:W3CDTF">2021-10-05T03:27:33Z</dcterms:modified>
</cp:coreProperties>
</file>